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55" r:id="rId2"/>
  </p:sldIdLst>
  <p:sldSz cx="9144000" cy="6858000" type="screen4x3"/>
  <p:notesSz cx="6742113" cy="9872663"/>
  <p:defaultTextStyle>
    <a:defPPr>
      <a:defRPr lang="ja-JP"/>
    </a:defPPr>
    <a:lvl1pPr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5613" indent="1588"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2813" indent="1588"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0013" indent="1588"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7213" indent="1588"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327" autoAdjust="0"/>
    <p:restoredTop sz="92599" autoAdjust="0"/>
  </p:normalViewPr>
  <p:slideViewPr>
    <p:cSldViewPr>
      <p:cViewPr>
        <p:scale>
          <a:sx n="100" d="100"/>
          <a:sy n="100" d="100"/>
        </p:scale>
        <p:origin x="-318" y="-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10" d="100"/>
        <a:sy n="11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2" y="1"/>
            <a:ext cx="2922165" cy="494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>
            <a:lvl1pPr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 bwMode="auto">
          <a:xfrm>
            <a:off x="3818359" y="1"/>
            <a:ext cx="2922164" cy="494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>
            <a:lvl1pPr algn="r"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3105AF1E-4E15-4D86-9AE2-6405E0CC2F33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 bwMode="auto">
          <a:xfrm>
            <a:off x="2" y="9377044"/>
            <a:ext cx="2922165" cy="494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b" anchorCtr="0" compatLnSpc="1">
            <a:prstTxWarp prst="textNoShape">
              <a:avLst/>
            </a:prstTxWarp>
          </a:bodyPr>
          <a:lstStyle>
            <a:lvl1pPr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 bwMode="auto">
          <a:xfrm>
            <a:off x="3818359" y="9377044"/>
            <a:ext cx="2922164" cy="494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b" anchorCtr="0" compatLnSpc="1">
            <a:prstTxWarp prst="textNoShape">
              <a:avLst/>
            </a:prstTxWarp>
          </a:bodyPr>
          <a:lstStyle>
            <a:lvl1pPr algn="r"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C9DF11FB-65CE-4FC1-B076-62140F324397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7832237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2" y="1"/>
            <a:ext cx="2922165" cy="494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>
            <a:lvl1pPr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 bwMode="auto">
          <a:xfrm>
            <a:off x="3818359" y="1"/>
            <a:ext cx="2922164" cy="494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>
            <a:lvl1pPr algn="r"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2BEA22E5-B045-4FFB-BDE3-7CB0F67FC63F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4875" y="741363"/>
            <a:ext cx="4933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399" tIns="45199" rIns="90399" bIns="45199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 bwMode="auto">
          <a:xfrm>
            <a:off x="673736" y="4689316"/>
            <a:ext cx="5394644" cy="4443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 bwMode="auto">
          <a:xfrm>
            <a:off x="2" y="9377044"/>
            <a:ext cx="2922165" cy="494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b" anchorCtr="0" compatLnSpc="1">
            <a:prstTxWarp prst="textNoShape">
              <a:avLst/>
            </a:prstTxWarp>
          </a:bodyPr>
          <a:lstStyle>
            <a:lvl1pPr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 bwMode="auto">
          <a:xfrm>
            <a:off x="3818359" y="9377044"/>
            <a:ext cx="2922164" cy="494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b" anchorCtr="0" compatLnSpc="1">
            <a:prstTxWarp prst="textNoShape">
              <a:avLst/>
            </a:prstTxWarp>
          </a:bodyPr>
          <a:lstStyle>
            <a:lvl1pPr algn="r"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608E5564-492A-4709-8AE1-2C4782E93EB4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62886760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5613"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2813"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0013"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7213"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608E5564-492A-4709-8AE1-2C4782E93EB4}" type="slidenum">
              <a:rPr lang="ja-JP" altLang="en-US" smtClean="0"/>
              <a:pPr>
                <a:defRPr/>
              </a:pPr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63776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76FA2F-40D6-4B7A-A5BF-BFCD10F8D9FC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097FA8-CBEA-473C-9526-C30AAEFFC6A6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27541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81C6-C9BA-447C-8F2B-146A0B4AB44D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A19835-9D0E-4836-A6F6-AD033EF7EC27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60825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1AC872-789C-467C-B5B0-1AEC4BFB19F1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C8B49A-3108-4555-8BC5-51CFF834B00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247672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070B3-B648-4C9A-90EA-D75E11F22486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266205-E780-4421-93F0-3B4BB3FCC29A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58746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5B4780-B960-488E-A886-385E3376EB0A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9EE6A3-17FD-4FA1-9BD7-B0530626A579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06123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3C3EE9-B353-40AF-B0CA-4ACE09C1EB0C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A63218-338C-4CBE-867A-70CAEFAEC790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61560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B4967F-CBEA-4C2C-9445-92D6BCE04D73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F361D6-1C25-46AB-9E17-CEF98220C840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2244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FBAC7B-0508-424E-8A87-955D0CD65026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BEBAE1-76D6-41A3-B297-A830AA1F584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616959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8601B9-0792-4F19-BB77-43A27CEB9DD1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D62EFF-87C7-4B0F-93CE-C33F0874D29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13311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EFF399-F815-4008-AB86-8C97CDF1DF30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BFB662-0FCB-4E3A-ABC3-DCBDB40CD596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85056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8390D-1293-4B00-AD60-A1D22CA619CF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F651E5-189E-43A7-A01A-FC2171028E8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712452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B844AEE3-D0BE-45E8-89B6-896DE9B722A2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FA27CA32-CE71-414F-BEC2-F9E7CA0B3A62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2813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912813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defTabSz="912813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defTabSz="912813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defTabSz="912813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1313" indent="-3413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/>
          <p:cNvGrpSpPr/>
          <p:nvPr/>
        </p:nvGrpSpPr>
        <p:grpSpPr>
          <a:xfrm>
            <a:off x="1831115" y="1052736"/>
            <a:ext cx="6043752" cy="3069922"/>
            <a:chOff x="1831115" y="1412776"/>
            <a:chExt cx="6043752" cy="3069922"/>
          </a:xfrm>
        </p:grpSpPr>
        <p:sp>
          <p:nvSpPr>
            <p:cNvPr id="2" name="テキスト ボックス 1"/>
            <p:cNvSpPr txBox="1"/>
            <p:nvPr/>
          </p:nvSpPr>
          <p:spPr>
            <a:xfrm>
              <a:off x="3083422" y="1412776"/>
              <a:ext cx="7120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 smtClean="0"/>
                <a:t>SKRC-1</a:t>
              </a:r>
              <a:endParaRPr kumimoji="1" lang="ja-JP" altLang="en-US" sz="1100" b="1" dirty="0"/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5426468" y="1412776"/>
              <a:ext cx="79060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 smtClean="0"/>
                <a:t>SKRC-44</a:t>
              </a:r>
              <a:endParaRPr kumimoji="1" lang="ja-JP" altLang="en-US" sz="1100" b="1" dirty="0"/>
            </a:p>
          </p:txBody>
        </p:sp>
        <p:sp>
          <p:nvSpPr>
            <p:cNvPr id="16" name="Line 45"/>
            <p:cNvSpPr>
              <a:spLocks noChangeShapeType="1"/>
            </p:cNvSpPr>
            <p:nvPr/>
          </p:nvSpPr>
          <p:spPr bwMode="auto">
            <a:xfrm>
              <a:off x="1979712" y="4325503"/>
              <a:ext cx="507820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 type="none" w="med" len="med"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900" b="1"/>
            </a:p>
          </p:txBody>
        </p:sp>
        <p:sp>
          <p:nvSpPr>
            <p:cNvPr id="17" name="Line 45"/>
            <p:cNvSpPr>
              <a:spLocks noChangeShapeType="1"/>
            </p:cNvSpPr>
            <p:nvPr/>
          </p:nvSpPr>
          <p:spPr bwMode="auto">
            <a:xfrm flipV="1">
              <a:off x="1979712" y="2060848"/>
              <a:ext cx="0" cy="225524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 type="none" w="med" len="med"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900" b="1"/>
            </a:p>
          </p:txBody>
        </p:sp>
        <p:sp>
          <p:nvSpPr>
            <p:cNvPr id="18" name="Text Box 47"/>
            <p:cNvSpPr txBox="1">
              <a:spLocks noChangeArrowheads="1"/>
            </p:cNvSpPr>
            <p:nvPr/>
          </p:nvSpPr>
          <p:spPr bwMode="auto">
            <a:xfrm>
              <a:off x="3923928" y="4221088"/>
              <a:ext cx="1313180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100" b="1" dirty="0" err="1" smtClean="0"/>
                <a:t>Annexin</a:t>
              </a:r>
              <a:r>
                <a:rPr lang="en-US" altLang="ja-JP" sz="1100" b="1" dirty="0" smtClean="0"/>
                <a:t> V - FITC</a:t>
              </a:r>
              <a:endParaRPr lang="en-US" altLang="ja-JP" sz="1100" b="1" dirty="0"/>
            </a:p>
          </p:txBody>
        </p:sp>
        <p:sp>
          <p:nvSpPr>
            <p:cNvPr id="19" name="Text Box 48"/>
            <p:cNvSpPr txBox="1">
              <a:spLocks noChangeArrowheads="1"/>
            </p:cNvSpPr>
            <p:nvPr/>
          </p:nvSpPr>
          <p:spPr bwMode="auto">
            <a:xfrm rot="16200000">
              <a:off x="1807643" y="2915816"/>
              <a:ext cx="31771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100" b="1" dirty="0" smtClean="0"/>
                <a:t>PI</a:t>
              </a:r>
              <a:endParaRPr lang="en-US" altLang="ja-JP" sz="1100" b="1" dirty="0"/>
            </a:p>
          </p:txBody>
        </p:sp>
        <p:pic>
          <p:nvPicPr>
            <p:cNvPr id="1031" name="Picture 7" descr="D:\Shimane Univ\RCC+pIC Manuscripts\FACS DATA for Figures_Tiff files\140725 RCC+siC2+pIC_FACS Figures\140725 SKRC1+siCont+pIC.tif"/>
            <p:cNvPicPr preferRelativeResize="0"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85778" y="3114247"/>
              <a:ext cx="1197704" cy="10597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2" name="Picture 8" descr="D:\Shimane Univ\RCC+pIC Manuscripts\FACS DATA for Figures_Tiff files\140725 RCC+siC2+pIC_FACS Figures\140725 SKRC1+siCasp2(-).tif"/>
            <p:cNvPicPr preferRelativeResize="0"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3221" y="1913106"/>
              <a:ext cx="1197704" cy="10597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D:\Shimane Univ\RCC+pIC Manuscripts\FACS DATA for Figures_Tiff files\140725 RCC+siC2+pIC_FACS Figures\140725 SKRC1+siCasp2+pIC.tif"/>
            <p:cNvPicPr preferRelativeResize="0"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3221" y="3114247"/>
              <a:ext cx="1197704" cy="10597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4" name="Picture 10" descr="D:\Shimane Univ\RCC+pIC Manuscripts\FACS DATA for Figures_Tiff files\140725 RCC+siC2+pIC_FACS Figures\140725 SKRC1+siCont(-).tif"/>
            <p:cNvPicPr preferRelativeResize="0"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85778" y="1922154"/>
              <a:ext cx="1197704" cy="10507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8" name="テキスト ボックス 37"/>
            <p:cNvSpPr txBox="1"/>
            <p:nvPr/>
          </p:nvSpPr>
          <p:spPr>
            <a:xfrm>
              <a:off x="2558992" y="1700808"/>
              <a:ext cx="5728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線コネクタ 38"/>
            <p:cNvCxnSpPr/>
            <p:nvPr/>
          </p:nvCxnSpPr>
          <p:spPr>
            <a:xfrm>
              <a:off x="2298577" y="1664658"/>
              <a:ext cx="218234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/>
            <p:cNvSpPr txBox="1"/>
            <p:nvPr/>
          </p:nvSpPr>
          <p:spPr>
            <a:xfrm>
              <a:off x="3707904" y="1700808"/>
              <a:ext cx="6550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p-2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5" name="Picture 11" descr="D:\Shimane Univ\RCC+pIC Manuscripts\FACS DATA for Figures_Tiff files\140725 RCC+siC2+pIC_FACS Figures\140725 SKRC44+siCont+pIC.tif"/>
            <p:cNvPicPr preferRelativeResize="0"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29685" y="3114253"/>
              <a:ext cx="1194583" cy="10597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6" name="Picture 12" descr="D:\Shimane Univ\RCC+pIC Manuscripts\FACS DATA for Figures_Tiff files\140725 RCC+siC2+pIC_FACS Figures\140725 SKRC44+siCasp2(-).tif"/>
            <p:cNvPicPr preferRelativeResize="0"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82674" y="1913106"/>
              <a:ext cx="1197705" cy="105073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7" name="Picture 13" descr="D:\Shimane Univ\RCC+pIC Manuscripts\FACS DATA for Figures_Tiff files\140725 RCC+siC2+pIC_FACS Figures\140725 SKRC44+siCasp2+pIC.tif"/>
            <p:cNvPicPr preferRelativeResize="0"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82674" y="3114253"/>
              <a:ext cx="1197705" cy="10597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8" name="Picture 14" descr="D:\Shimane Univ\RCC+pIC Manuscripts\FACS DATA for Figures_Tiff files\140725 RCC+siC2+pIC_FACS Figures\140725 SKRC44+siCont(-).tif"/>
            <p:cNvPicPr preferRelativeResize="0"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29685" y="1913106"/>
              <a:ext cx="1194583" cy="105073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8" name="テキスト ボックス 47"/>
            <p:cNvSpPr txBox="1"/>
            <p:nvPr/>
          </p:nvSpPr>
          <p:spPr>
            <a:xfrm>
              <a:off x="5076056" y="1700808"/>
              <a:ext cx="5728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直線コネクタ 48"/>
            <p:cNvCxnSpPr/>
            <p:nvPr/>
          </p:nvCxnSpPr>
          <p:spPr>
            <a:xfrm>
              <a:off x="4772956" y="1669722"/>
              <a:ext cx="218234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テキスト ボックス 49"/>
            <p:cNvSpPr txBox="1"/>
            <p:nvPr/>
          </p:nvSpPr>
          <p:spPr>
            <a:xfrm>
              <a:off x="6293181" y="1700808"/>
              <a:ext cx="6550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p-2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2918890" y="1919092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2917807" y="2577596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4107268" y="1919092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4106184" y="2577596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2845550" y="3143228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.0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2845550" y="3801550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.3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4072081" y="3143228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.6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4072081" y="3801550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.6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2347519" y="1919092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3546425" y="1919092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7</a:t>
              </a:r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2347519" y="3143228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.6</a:t>
              </a: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3546425" y="3143228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.9</a:t>
              </a: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5476184" y="1916832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7</a:t>
              </a: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>
              <a:off x="5476184" y="2575336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6735548" y="1916832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6734464" y="2575336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8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5418974" y="3140968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.9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5418974" y="3799290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.1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6700361" y="3140968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.3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6700361" y="3799290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.8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テキスト ボックス 72"/>
            <p:cNvSpPr txBox="1"/>
            <p:nvPr/>
          </p:nvSpPr>
          <p:spPr>
            <a:xfrm>
              <a:off x="4904811" y="1916832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6103718" y="1916832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75" name="テキスト ボックス 74"/>
            <p:cNvSpPr txBox="1"/>
            <p:nvPr/>
          </p:nvSpPr>
          <p:spPr>
            <a:xfrm>
              <a:off x="4904811" y="3140968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.4</a:t>
              </a: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6103718" y="3140968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.9</a:t>
              </a:r>
            </a:p>
          </p:txBody>
        </p:sp>
        <p:sp>
          <p:nvSpPr>
            <p:cNvPr id="59" name="テキスト ボックス 115"/>
            <p:cNvSpPr txBox="1">
              <a:spLocks noChangeArrowheads="1"/>
            </p:cNvSpPr>
            <p:nvPr/>
          </p:nvSpPr>
          <p:spPr bwMode="auto">
            <a:xfrm>
              <a:off x="7092280" y="2240308"/>
              <a:ext cx="78258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defTabSz="914400" eaLnBrk="1" hangingPunct="1"/>
              <a:r>
                <a:rPr lang="en-US" altLang="ja-JP" sz="1000" b="1" dirty="0">
                  <a:cs typeface="Arial" charset="0"/>
                </a:rPr>
                <a:t>Untreated</a:t>
              </a:r>
              <a:endParaRPr lang="ja-JP" altLang="en-US" sz="1000" dirty="0">
                <a:cs typeface="Arial" charset="0"/>
              </a:endParaRPr>
            </a:p>
          </p:txBody>
        </p:sp>
        <p:sp>
          <p:nvSpPr>
            <p:cNvPr id="78" name="テキスト ボックス 117"/>
            <p:cNvSpPr txBox="1">
              <a:spLocks noChangeArrowheads="1"/>
            </p:cNvSpPr>
            <p:nvPr/>
          </p:nvSpPr>
          <p:spPr bwMode="auto">
            <a:xfrm>
              <a:off x="7092280" y="3470811"/>
              <a:ext cx="59182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defTabSz="914400" eaLnBrk="1" hangingPunct="1"/>
              <a:r>
                <a:rPr lang="en-US" altLang="ja-JP" sz="1000" b="1" dirty="0" err="1">
                  <a:cs typeface="Arial" charset="0"/>
                </a:rPr>
                <a:t>pIC</a:t>
              </a:r>
              <a:r>
                <a:rPr lang="en-US" altLang="ja-JP" sz="1000" b="1" dirty="0">
                  <a:cs typeface="Arial" charset="0"/>
                </a:rPr>
                <a:t>-TF</a:t>
              </a:r>
              <a:endParaRPr lang="ja-JP" altLang="en-US" sz="1000" dirty="0">
                <a:cs typeface="Arial" charset="0"/>
              </a:endParaRPr>
            </a:p>
          </p:txBody>
        </p:sp>
        <p:sp>
          <p:nvSpPr>
            <p:cNvPr id="80" name="テキスト ボックス 315"/>
            <p:cNvSpPr txBox="1">
              <a:spLocks noChangeArrowheads="1"/>
            </p:cNvSpPr>
            <p:nvPr/>
          </p:nvSpPr>
          <p:spPr bwMode="auto">
            <a:xfrm>
              <a:off x="7086962" y="1934295"/>
              <a:ext cx="36420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defTabSz="914400" eaLnBrk="1" hangingPunct="1"/>
              <a:r>
                <a:rPr lang="en-US" altLang="ja-JP" sz="900" b="1" dirty="0">
                  <a:cs typeface="Arial" charset="0"/>
                </a:rPr>
                <a:t>(%)</a:t>
              </a:r>
              <a:endParaRPr lang="ja-JP" altLang="en-US" sz="900" b="1" dirty="0">
                <a:cs typeface="Arial" charset="0"/>
              </a:endParaRPr>
            </a:p>
          </p:txBody>
        </p:sp>
        <p:sp>
          <p:nvSpPr>
            <p:cNvPr id="3" name="テキスト ボックス 2"/>
            <p:cNvSpPr txBox="1"/>
            <p:nvPr/>
          </p:nvSpPr>
          <p:spPr>
            <a:xfrm>
              <a:off x="1831115" y="1686000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/>
                <a:t>siRNA</a:t>
              </a:r>
              <a:endParaRPr kumimoji="1" lang="ja-JP" altLang="en-US" sz="900" b="1" dirty="0"/>
            </a:p>
          </p:txBody>
        </p:sp>
      </p:grpSp>
      <p:sp>
        <p:nvSpPr>
          <p:cNvPr id="4" name="正方形/長方形 3"/>
          <p:cNvSpPr/>
          <p:nvPr/>
        </p:nvSpPr>
        <p:spPr>
          <a:xfrm>
            <a:off x="1528869" y="4437112"/>
            <a:ext cx="634599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/>
              <a:t>Supplemental Figure 1. Effects of </a:t>
            </a:r>
            <a:r>
              <a:rPr lang="en-US" altLang="ja-JP" sz="1200" b="1" dirty="0" smtClean="0"/>
              <a:t>caspase-2 knockdown </a:t>
            </a:r>
            <a:r>
              <a:rPr lang="en-US" altLang="ja-JP" sz="1200" b="1" dirty="0"/>
              <a:t>on </a:t>
            </a:r>
            <a:r>
              <a:rPr lang="en-US" altLang="ja-JP" sz="1200" b="1" dirty="0" smtClean="0"/>
              <a:t>apoptosis in poly(I:C) transfected RCC cells. </a:t>
            </a:r>
            <a:r>
              <a:rPr lang="en-US" altLang="ja-JP" sz="1200" dirty="0"/>
              <a:t>Both cell lines, which were pre-transfected with control or caspase-2 siRNA 3 days prior, were transfected additionally with poly(I:C) (SKRC-1, 1,000 ng/ml; SKRC-44, 500 ng/ml). Cells were then stained with FITC-conjugated </a:t>
            </a:r>
            <a:r>
              <a:rPr lang="en-US" altLang="ja-JP" sz="1200" dirty="0" err="1"/>
              <a:t>Annexin</a:t>
            </a:r>
            <a:r>
              <a:rPr lang="en-US" altLang="ja-JP" sz="1200" dirty="0"/>
              <a:t> V and PI and analyzed by flow cytometry after 24 h. Numbers represent the percentages for each subset. </a:t>
            </a:r>
            <a:r>
              <a:rPr lang="en-US" altLang="ja-JP" sz="1200" dirty="0" err="1"/>
              <a:t>pIC</a:t>
            </a:r>
            <a:r>
              <a:rPr lang="en-US" altLang="ja-JP" sz="1200" dirty="0"/>
              <a:t>-TF, poly(I:C) transfection.</a:t>
            </a:r>
            <a:endParaRPr lang="ja-JP" altLang="ja-JP" sz="1200" dirty="0"/>
          </a:p>
        </p:txBody>
      </p:sp>
    </p:spTree>
    <p:extLst>
      <p:ext uri="{BB962C8B-B14F-4D97-AF65-F5344CB8AC3E}">
        <p14:creationId xmlns:p14="http://schemas.microsoft.com/office/powerpoint/2010/main" val="3487017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6</TotalTime>
  <Words>125</Words>
  <Application>Microsoft Office PowerPoint</Application>
  <PresentationFormat>画面に合わせる (4:3)</PresentationFormat>
  <Paragraphs>38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FJ-W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原嶋</dc:creator>
  <cp:lastModifiedBy>HARADA</cp:lastModifiedBy>
  <cp:revision>499</cp:revision>
  <cp:lastPrinted>2014-08-03T04:10:14Z</cp:lastPrinted>
  <dcterms:created xsi:type="dcterms:W3CDTF">2012-03-12T05:43:49Z</dcterms:created>
  <dcterms:modified xsi:type="dcterms:W3CDTF">2014-08-03T04:52:27Z</dcterms:modified>
</cp:coreProperties>
</file>